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embeddedFontLst>
    <p:embeddedFont>
      <p:font typeface="Arial Black" panose="020B0A04020102020204" pitchFamily="34" charset="0"/>
      <p:regular r:id="rId5"/>
      <p:bold r:id="rId6"/>
    </p:embeddedFont>
    <p:embeddedFont>
      <p:font typeface="Calibri" panose="020F0502020204030204" pitchFamily="34" charset="0"/>
      <p:regular r:id="rId7"/>
      <p:bold r:id="rId8"/>
      <p:italic r:id="rId9"/>
      <p:boldItalic r:id="rId10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1" roundtripDataSignature="AMtx7mhjoCT3NvQfHLblzsTIySts2Bf9z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13" d="100"/>
          <a:sy n="113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customschemas.google.com/relationships/presentationmetadata" Target="metadata"/><Relationship Id="rId5" Type="http://schemas.openxmlformats.org/officeDocument/2006/relationships/font" Target="fonts/font1.fntdata"/><Relationship Id="rId15" Type="http://schemas.openxmlformats.org/officeDocument/2006/relationships/tableStyles" Target="tableStyles.xml"/><Relationship Id="rId10" Type="http://schemas.openxmlformats.org/officeDocument/2006/relationships/font" Target="fonts/font6.fntdata"/><Relationship Id="rId4" Type="http://schemas.openxmlformats.org/officeDocument/2006/relationships/notesMaster" Target="notesMasters/notesMaster1.xml"/><Relationship Id="rId9" Type="http://schemas.openxmlformats.org/officeDocument/2006/relationships/font" Target="fonts/font5.fntdata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illot, Adrien" userId="71e1903a-7099-48ea-8df4-2be6f32e921c" providerId="ADAL" clId="{D03FE8B6-101F-43EE-986D-F1A064E58315}"/>
    <pc:docChg chg="custSel modSld">
      <pc:chgData name="Guillot, Adrien" userId="71e1903a-7099-48ea-8df4-2be6f32e921c" providerId="ADAL" clId="{D03FE8B6-101F-43EE-986D-F1A064E58315}" dt="2025-03-11T16:50:58.245" v="13" actId="1036"/>
      <pc:docMkLst>
        <pc:docMk/>
      </pc:docMkLst>
      <pc:sldChg chg="addSp delSp modSp">
        <pc:chgData name="Guillot, Adrien" userId="71e1903a-7099-48ea-8df4-2be6f32e921c" providerId="ADAL" clId="{D03FE8B6-101F-43EE-986D-F1A064E58315}" dt="2025-03-11T16:50:58.245" v="13" actId="1036"/>
        <pc:sldMkLst>
          <pc:docMk/>
          <pc:sldMk cId="0" sldId="257"/>
        </pc:sldMkLst>
        <pc:spChg chg="mod">
          <ac:chgData name="Guillot, Adrien" userId="71e1903a-7099-48ea-8df4-2be6f32e921c" providerId="ADAL" clId="{D03FE8B6-101F-43EE-986D-F1A064E58315}" dt="2025-03-11T16:50:58.245" v="13" actId="1036"/>
          <ac:spMkLst>
            <pc:docMk/>
            <pc:sldMk cId="0" sldId="257"/>
            <ac:spMk id="4" creationId="{12661C7F-E3C4-7347-D4E5-1043F7CE9304}"/>
          </ac:spMkLst>
        </pc:spChg>
        <pc:picChg chg="del">
          <ac:chgData name="Guillot, Adrien" userId="71e1903a-7099-48ea-8df4-2be6f32e921c" providerId="ADAL" clId="{D03FE8B6-101F-43EE-986D-F1A064E58315}" dt="2025-03-11T16:50:05.226" v="0" actId="478"/>
          <ac:picMkLst>
            <pc:docMk/>
            <pc:sldMk cId="0" sldId="257"/>
            <ac:picMk id="3" creationId="{C758AD8C-FD3D-01AB-4999-42EA2E8E3716}"/>
          </ac:picMkLst>
        </pc:picChg>
        <pc:picChg chg="add mod">
          <ac:chgData name="Guillot, Adrien" userId="71e1903a-7099-48ea-8df4-2be6f32e921c" providerId="ADAL" clId="{D03FE8B6-101F-43EE-986D-F1A064E58315}" dt="2025-03-11T16:50:58.245" v="13" actId="1036"/>
          <ac:picMkLst>
            <pc:docMk/>
            <pc:sldMk cId="0" sldId="257"/>
            <ac:picMk id="5" creationId="{40F4A862-26D4-4CB4-89E0-C762D5B15C28}"/>
          </ac:picMkLst>
        </pc:picChg>
      </pc:sldChg>
    </pc:docChg>
  </pc:docChgLst>
  <pc:docChgLst>
    <pc:chgData name="Guillot, Adrien" userId="71e1903a-7099-48ea-8df4-2be6f32e921c" providerId="ADAL" clId="{5D11F201-0830-4002-B099-D8AAC10A0C15}"/>
    <pc:docChg chg="custSel modSld">
      <pc:chgData name="Guillot, Adrien" userId="71e1903a-7099-48ea-8df4-2be6f32e921c" providerId="ADAL" clId="{5D11F201-0830-4002-B099-D8AAC10A0C15}" dt="2025-03-18T16:12:19.741" v="31" actId="12788"/>
      <pc:docMkLst>
        <pc:docMk/>
      </pc:docMkLst>
      <pc:sldChg chg="addSp delSp modSp">
        <pc:chgData name="Guillot, Adrien" userId="71e1903a-7099-48ea-8df4-2be6f32e921c" providerId="ADAL" clId="{5D11F201-0830-4002-B099-D8AAC10A0C15}" dt="2025-03-18T16:12:19.741" v="31" actId="12788"/>
        <pc:sldMkLst>
          <pc:docMk/>
          <pc:sldMk cId="0" sldId="257"/>
        </pc:sldMkLst>
        <pc:picChg chg="add del mod">
          <ac:chgData name="Guillot, Adrien" userId="71e1903a-7099-48ea-8df4-2be6f32e921c" providerId="ADAL" clId="{5D11F201-0830-4002-B099-D8AAC10A0C15}" dt="2025-03-18T16:12:08.180" v="26" actId="478"/>
          <ac:picMkLst>
            <pc:docMk/>
            <pc:sldMk cId="0" sldId="257"/>
            <ac:picMk id="3" creationId="{D6401E39-1D57-4E45-A924-FDE5D4ED971E}"/>
          </ac:picMkLst>
        </pc:picChg>
        <pc:picChg chg="add mod">
          <ac:chgData name="Guillot, Adrien" userId="71e1903a-7099-48ea-8df4-2be6f32e921c" providerId="ADAL" clId="{5D11F201-0830-4002-B099-D8AAC10A0C15}" dt="2025-03-18T16:12:19.741" v="31" actId="12788"/>
          <ac:picMkLst>
            <pc:docMk/>
            <pc:sldMk cId="0" sldId="257"/>
            <ac:picMk id="5" creationId="{17B8A136-6DD0-475F-BF03-FFFCD0CB1BC7}"/>
          </ac:picMkLst>
        </pc:picChg>
        <pc:picChg chg="del">
          <ac:chgData name="Guillot, Adrien" userId="71e1903a-7099-48ea-8df4-2be6f32e921c" providerId="ADAL" clId="{5D11F201-0830-4002-B099-D8AAC10A0C15}" dt="2025-03-18T14:43:19.316" v="0" actId="478"/>
          <ac:picMkLst>
            <pc:docMk/>
            <pc:sldMk cId="0" sldId="257"/>
            <ac:picMk id="5" creationId="{40F4A862-26D4-4CB4-89E0-C762D5B15C28}"/>
          </ac:picMkLst>
        </pc:picChg>
      </pc:sldChg>
    </pc:docChg>
  </pc:docChgLst>
  <pc:docChgLst>
    <pc:chgData name="Liu, Hanyang (NIH/NCI) [F]" userId="8bdfefd7-e832-4c1c-91e3-c61300ecb998" providerId="ADAL" clId="{D95A225D-CE76-B740-B0AA-7EC69A8943B1}"/>
    <pc:docChg chg="modSld">
      <pc:chgData name="Liu, Hanyang (NIH/NCI) [F]" userId="8bdfefd7-e832-4c1c-91e3-c61300ecb998" providerId="ADAL" clId="{D95A225D-CE76-B740-B0AA-7EC69A8943B1}" dt="2025-03-11T12:52:04.188" v="51" actId="1076"/>
      <pc:docMkLst>
        <pc:docMk/>
      </pc:docMkLst>
      <pc:sldChg chg="mod modShow">
        <pc:chgData name="Liu, Hanyang (NIH/NCI) [F]" userId="8bdfefd7-e832-4c1c-91e3-c61300ecb998" providerId="ADAL" clId="{D95A225D-CE76-B740-B0AA-7EC69A8943B1}" dt="2025-03-10T13:19:23.013" v="9" actId="729"/>
        <pc:sldMkLst>
          <pc:docMk/>
          <pc:sldMk cId="0" sldId="256"/>
        </pc:sldMkLst>
      </pc:sldChg>
      <pc:sldChg chg="addSp delSp modSp mod modNotes">
        <pc:chgData name="Liu, Hanyang (NIH/NCI) [F]" userId="8bdfefd7-e832-4c1c-91e3-c61300ecb998" providerId="ADAL" clId="{D95A225D-CE76-B740-B0AA-7EC69A8943B1}" dt="2025-03-11T12:52:04.188" v="51" actId="1076"/>
        <pc:sldMkLst>
          <pc:docMk/>
          <pc:sldMk cId="0" sldId="257"/>
        </pc:sldMkLst>
        <pc:spChg chg="add mod">
          <ac:chgData name="Liu, Hanyang (NIH/NCI) [F]" userId="8bdfefd7-e832-4c1c-91e3-c61300ecb998" providerId="ADAL" clId="{D95A225D-CE76-B740-B0AA-7EC69A8943B1}" dt="2025-03-11T12:52:04.188" v="51" actId="1076"/>
          <ac:spMkLst>
            <pc:docMk/>
            <pc:sldMk cId="0" sldId="257"/>
            <ac:spMk id="4" creationId="{12661C7F-E3C4-7347-D4E5-1043F7CE9304}"/>
          </ac:spMkLst>
        </pc:spChg>
        <pc:spChg chg="add del mod">
          <ac:chgData name="Liu, Hanyang (NIH/NCI) [F]" userId="8bdfefd7-e832-4c1c-91e3-c61300ecb998" providerId="ADAL" clId="{D95A225D-CE76-B740-B0AA-7EC69A8943B1}" dt="2025-03-10T13:19:18.669" v="8"/>
          <ac:spMkLst>
            <pc:docMk/>
            <pc:sldMk cId="0" sldId="257"/>
            <ac:spMk id="4" creationId="{5FA4EEF9-EEC1-08D2-D138-387066FCFBFE}"/>
          </ac:spMkLst>
        </pc:spChg>
        <pc:spChg chg="add del mod">
          <ac:chgData name="Liu, Hanyang (NIH/NCI) [F]" userId="8bdfefd7-e832-4c1c-91e3-c61300ecb998" providerId="ADAL" clId="{D95A225D-CE76-B740-B0AA-7EC69A8943B1}" dt="2025-03-11T12:51:45.691" v="42"/>
          <ac:spMkLst>
            <pc:docMk/>
            <pc:sldMk cId="0" sldId="257"/>
            <ac:spMk id="5" creationId="{B34F88A1-93E4-E608-1F92-86DEA4CEB49C}"/>
          </ac:spMkLst>
        </pc:spChg>
        <pc:spChg chg="mod">
          <ac:chgData name="Liu, Hanyang (NIH/NCI) [F]" userId="8bdfefd7-e832-4c1c-91e3-c61300ecb998" providerId="ADAL" clId="{D95A225D-CE76-B740-B0AA-7EC69A8943B1}" dt="2025-03-10T13:19:14.551" v="5" actId="1076"/>
          <ac:spMkLst>
            <pc:docMk/>
            <pc:sldMk cId="0" sldId="257"/>
            <ac:spMk id="92" creationId="{00000000-0000-0000-0000-000000000000}"/>
          </ac:spMkLst>
        </pc:spChg>
        <pc:picChg chg="add mod">
          <ac:chgData name="Liu, Hanyang (NIH/NCI) [F]" userId="8bdfefd7-e832-4c1c-91e3-c61300ecb998" providerId="ADAL" clId="{D95A225D-CE76-B740-B0AA-7EC69A8943B1}" dt="2025-03-11T12:50:35.189" v="12" actId="1076"/>
          <ac:picMkLst>
            <pc:docMk/>
            <pc:sldMk cId="0" sldId="257"/>
            <ac:picMk id="3" creationId="{C758AD8C-FD3D-01AB-4999-42EA2E8E371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gut.bmj.com/pages/visual-abstracts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mailto:info.gut@bmj.com" TargetMode="External"/><Relationship Id="rId4" Type="http://schemas.openxmlformats.org/officeDocument/2006/relationships/hyperlink" Target="https://www.canva.com/infographics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>
            <a:spLocks noGrp="1"/>
          </p:cNvSpPr>
          <p:nvPr>
            <p:ph type="title"/>
          </p:nvPr>
        </p:nvSpPr>
        <p:spPr>
          <a:xfrm>
            <a:off x="838200" y="365126"/>
            <a:ext cx="10515600" cy="6593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3600"/>
              <a:buFont typeface="Arial"/>
              <a:buNone/>
            </a:pPr>
            <a:r>
              <a:rPr lang="en-GB" sz="360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: Author Instructions for Visual Abstracts (VAs)</a:t>
            </a:r>
            <a:endParaRPr sz="3600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" name="Google Shape;85;p1"/>
          <p:cNvSpPr txBox="1">
            <a:spLocks noGrp="1"/>
          </p:cNvSpPr>
          <p:nvPr>
            <p:ph type="body" idx="1"/>
          </p:nvPr>
        </p:nvSpPr>
        <p:spPr>
          <a:xfrm>
            <a:off x="406399" y="1024467"/>
            <a:ext cx="11565468" cy="5748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86526" lvl="0" indent="0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64"/>
              <a:buNone/>
            </a:pPr>
            <a:r>
              <a:rPr lang="en-GB" sz="1400" b="1" i="0" u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he visual abstract is an opportunity for authors to present the key findings of their work in a pictorial manner to increase the visibility of their paper. See past Gut </a:t>
            </a:r>
            <a:r>
              <a:rPr lang="en-GB" sz="14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visual abstracts </a:t>
            </a:r>
            <a:r>
              <a:rPr lang="en-GB" sz="1400" b="1" u="sng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ere</a:t>
            </a:r>
            <a:r>
              <a:rPr lang="en-GB" sz="14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400" b="1" i="0" u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86526" lvl="0" indent="0" algn="l" rtl="0">
              <a:lnSpc>
                <a:spcPct val="130000"/>
              </a:lnSpc>
              <a:spcBef>
                <a:spcPts val="750"/>
              </a:spcBef>
              <a:spcAft>
                <a:spcPts val="0"/>
              </a:spcAft>
              <a:buClr>
                <a:srgbClr val="F29806"/>
              </a:buClr>
              <a:buSzPts val="1864"/>
              <a:buNone/>
            </a:pPr>
            <a:r>
              <a:rPr lang="en-GB" sz="1400" b="1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idance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Use the template slide provided (next slide). The visual abstract should be one slide only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Make sure add the manuscript title and update the year &amp; manuscript DOI as highlighted in the template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VAs should be mainly pictorial, other than key messages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Only use original images. We encourage you to use images from your paper. Copyrighted images should NOT be used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Free online services such as </a:t>
            </a:r>
            <a:r>
              <a:rPr lang="en-GB" sz="1400" b="1" u="sng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4"/>
              </a:rPr>
              <a:t>Canva</a:t>
            </a: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 may be helpful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324"/>
              <a:buChar char="•"/>
            </a:pPr>
            <a:r>
              <a:rPr lang="en-GB" sz="1400" b="1" i="0" u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lease do not add in any extra information that is not present in your paper.</a:t>
            </a:r>
            <a:endParaRPr sz="1400" b="1" i="0" u="none" strike="noStrike">
              <a:latin typeface="Arial"/>
              <a:ea typeface="Arial"/>
              <a:cs typeface="Arial"/>
              <a:sym typeface="Arial"/>
            </a:endParaRPr>
          </a:p>
          <a:p>
            <a:pPr marL="120811" lvl="0" indent="0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324"/>
              <a:buNone/>
            </a:pPr>
            <a:r>
              <a:rPr lang="en-GB" sz="1400" b="1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How to Submit</a:t>
            </a:r>
            <a:endParaRPr sz="1400" b="1">
              <a:latin typeface="Arial"/>
              <a:ea typeface="Arial"/>
              <a:cs typeface="Arial"/>
              <a:sym typeface="Arial"/>
            </a:endParaRPr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Upload your visual abstract at the same time as your revised manuscript. Name the file “Visual Abstract”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For any assistance, please contact </a:t>
            </a:r>
            <a:r>
              <a:rPr lang="en-GB" sz="1400" b="1" u="sng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5"/>
              </a:rPr>
              <a:t>info.gut@bmj.com</a:t>
            </a:r>
            <a:endParaRPr sz="1400" b="1">
              <a:latin typeface="Arial"/>
              <a:ea typeface="Arial"/>
              <a:cs typeface="Arial"/>
              <a:sym typeface="Arial"/>
            </a:endParaRPr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The Associate Editor handling your paper will review your VA to ensure it accurately reflects the contents. They may ask for revision before the VA is approved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Your VA will be covered by the same author license as the paper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If your paper is accepted and published, the VA will appear alongside it.</a:t>
            </a:r>
            <a:endParaRPr/>
          </a:p>
          <a:p>
            <a:pPr marL="120811" lvl="0" indent="0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324"/>
              <a:buNone/>
            </a:pPr>
            <a:r>
              <a:rPr lang="en-GB" sz="1400" b="1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Promotion</a:t>
            </a:r>
            <a:endParaRPr sz="1400" b="1">
              <a:latin typeface="Arial"/>
              <a:ea typeface="Arial"/>
              <a:cs typeface="Arial"/>
              <a:sym typeface="Arial"/>
            </a:endParaRPr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VAs will be promoted through the journal Twitter account (@Gut_BMJ).</a:t>
            </a:r>
            <a:endParaRPr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>
                <a:latin typeface="Arial"/>
                <a:ea typeface="Arial"/>
                <a:cs typeface="Arial"/>
                <a:sym typeface="Arial"/>
              </a:rPr>
              <a:t>Please tweet and retweet through your own account and those of co-authors and institutions. Use the hashtag #GutVisualAbstract and include a link to the paper.</a:t>
            </a:r>
            <a:br>
              <a:rPr lang="en-GB" sz="1200" b="1">
                <a:latin typeface="Arial"/>
                <a:ea typeface="Arial"/>
                <a:cs typeface="Arial"/>
                <a:sym typeface="Arial"/>
              </a:rPr>
            </a:br>
            <a:endParaRPr sz="1200" b="1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/>
          <p:nvPr/>
        </p:nvSpPr>
        <p:spPr>
          <a:xfrm>
            <a:off x="0" y="32173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2"/>
          <p:cNvSpPr txBox="1"/>
          <p:nvPr/>
        </p:nvSpPr>
        <p:spPr>
          <a:xfrm>
            <a:off x="395598" y="443888"/>
            <a:ext cx="11667066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400" b="0" i="0" u="none" strike="noStrike" cap="none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Reactive cholangiocyte-derived ORM2 drives a pathogenic modulation of the injured biliary niche through macrophage reprogramming</a:t>
            </a:r>
          </a:p>
        </p:txBody>
      </p:sp>
      <p:sp>
        <p:nvSpPr>
          <p:cNvPr id="93" name="Google Shape;93;p2"/>
          <p:cNvSpPr txBox="1"/>
          <p:nvPr/>
        </p:nvSpPr>
        <p:spPr>
          <a:xfrm>
            <a:off x="2225305" y="6462724"/>
            <a:ext cx="15156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sp>
        <p:nvSpPr>
          <p:cNvPr id="94" name="Google Shape;94;p2"/>
          <p:cNvSpPr txBox="1"/>
          <p:nvPr/>
        </p:nvSpPr>
        <p:spPr>
          <a:xfrm>
            <a:off x="3920242" y="6462724"/>
            <a:ext cx="13377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5" name="Google Shape;95;p2" descr="About BSG - BSG 2024 Live!"/>
          <p:cNvPicPr preferRelativeResize="0"/>
          <p:nvPr/>
        </p:nvPicPr>
        <p:blipFill rotWithShape="1">
          <a:blip r:embed="rId4">
            <a:alphaModFix/>
          </a:blip>
          <a:srcRect t="1184" r="60381"/>
          <a:stretch/>
        </p:blipFill>
        <p:spPr>
          <a:xfrm>
            <a:off x="1556489" y="6424110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6" name="Google Shape;96;p2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803621" y="6507480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97" name="Google Shape;97;p2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34525" y="6451400"/>
            <a:ext cx="1282494" cy="3078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2661C7F-E3C4-7347-D4E5-1043F7CE9304}"/>
              </a:ext>
            </a:extLst>
          </p:cNvPr>
          <p:cNvSpPr txBox="1"/>
          <p:nvPr/>
        </p:nvSpPr>
        <p:spPr>
          <a:xfrm>
            <a:off x="204992" y="5475091"/>
            <a:ext cx="90533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anyang Liu, et al. Gut 202x. DOI: 10.1136/gut-202x-xxxxxx [2025, Gut - gutjnl-2024-334425.R1]</a:t>
            </a:r>
            <a:endParaRPr lang="en-US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17B8A136-6DD0-475F-BF03-FFFCD0CB1BC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707" y="1787678"/>
            <a:ext cx="12024587" cy="3489149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7</Words>
  <Application>Microsoft Office PowerPoint</Application>
  <PresentationFormat>Breitbild</PresentationFormat>
  <Paragraphs>22</Paragraphs>
  <Slides>2</Slides>
  <Notes>2</Notes>
  <HiddenSlides>1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Arial Black</vt:lpstr>
      <vt:lpstr>arial</vt:lpstr>
      <vt:lpstr>Calibri</vt:lpstr>
      <vt:lpstr>Office Theme</vt:lpstr>
      <vt:lpstr>Gut: Author Instructions for Visual Abstracts (VAs)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ut: Author Instructions for Visual Abstracts (VAs)</dc:title>
  <dc:creator>Anna Savage</dc:creator>
  <cp:lastModifiedBy>Guillot, Adrien</cp:lastModifiedBy>
  <cp:revision>1</cp:revision>
  <dcterms:created xsi:type="dcterms:W3CDTF">2024-02-16T09:26:22Z</dcterms:created>
  <dcterms:modified xsi:type="dcterms:W3CDTF">2025-03-18T16:12:22Z</dcterms:modified>
</cp:coreProperties>
</file>